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4F00D-B3AB-4A4A-BF24-480E0B8435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BF999-17D4-441A-83FD-7213F3B929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4CF60-711D-449A-8C8D-FFBC3EDBEE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A2064B-86A0-42C7-8FD1-34CCE1867A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246A0-8793-488F-8CD2-DBE348124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E123C-3522-4DA5-B772-0F567318A8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F1C76-12B1-46DD-9A81-D62E740161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712BD-0DC0-470B-9A99-2D5CFF91D3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B7D09-825A-4400-8C33-78B1B2DE8C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2CFE5-D14B-49EE-BFA6-DD3609AF4E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B1F8C-5813-4B2B-B9BA-24D46072C2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6ECD3-2492-43C9-B2C1-0820554D1E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A48505-81D6-44E6-BECD-63D47EFD5B94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1189080" y="938160"/>
            <a:ext cx="4583160" cy="275580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1262160" y="4022640"/>
            <a:ext cx="4370400" cy="268308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939240" y="590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939240" y="3743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2745360" y="474804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4121640" y="46180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15"/>
          <p:cNvGrpSpPr/>
          <p:nvPr/>
        </p:nvGrpSpPr>
        <p:grpSpPr>
          <a:xfrm>
            <a:off x="3665520" y="2208240"/>
            <a:ext cx="144360" cy="42840"/>
            <a:chOff x="3665520" y="2208240"/>
            <a:chExt cx="144360" cy="42840"/>
          </a:xfrm>
        </p:grpSpPr>
        <p:sp>
          <p:nvSpPr>
            <p:cNvPr id="48" name="Straight Connector 10"/>
            <p:cNvSpPr/>
            <p:nvPr/>
          </p:nvSpPr>
          <p:spPr>
            <a:xfrm>
              <a:off x="3665520" y="2208240"/>
              <a:ext cx="14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Straight Connector 11"/>
            <p:cNvSpPr/>
            <p:nvPr/>
          </p:nvSpPr>
          <p:spPr>
            <a:xfrm flipV="1">
              <a:off x="3665520" y="220824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14"/>
            <p:cNvSpPr/>
            <p:nvPr/>
          </p:nvSpPr>
          <p:spPr>
            <a:xfrm flipV="1">
              <a:off x="3809880" y="221436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Group 16"/>
          <p:cNvGrpSpPr/>
          <p:nvPr/>
        </p:nvGrpSpPr>
        <p:grpSpPr>
          <a:xfrm>
            <a:off x="3781440" y="1709640"/>
            <a:ext cx="144360" cy="42840"/>
            <a:chOff x="3781440" y="1709640"/>
            <a:chExt cx="144360" cy="42840"/>
          </a:xfrm>
        </p:grpSpPr>
        <p:sp>
          <p:nvSpPr>
            <p:cNvPr id="52" name="Straight Connector 17"/>
            <p:cNvSpPr/>
            <p:nvPr/>
          </p:nvSpPr>
          <p:spPr>
            <a:xfrm>
              <a:off x="3781440" y="1709640"/>
              <a:ext cx="14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traight Connector 18"/>
            <p:cNvSpPr/>
            <p:nvPr/>
          </p:nvSpPr>
          <p:spPr>
            <a:xfrm flipV="1">
              <a:off x="3781440" y="170964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19"/>
            <p:cNvSpPr/>
            <p:nvPr/>
          </p:nvSpPr>
          <p:spPr>
            <a:xfrm flipV="1">
              <a:off x="3925800" y="171576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Straight Connector 21"/>
          <p:cNvSpPr/>
          <p:nvPr/>
        </p:nvSpPr>
        <p:spPr>
          <a:xfrm>
            <a:off x="4167360" y="1430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22"/>
          <p:cNvSpPr/>
          <p:nvPr/>
        </p:nvSpPr>
        <p:spPr>
          <a:xfrm flipV="1">
            <a:off x="4167360" y="143028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23"/>
          <p:cNvSpPr/>
          <p:nvPr/>
        </p:nvSpPr>
        <p:spPr>
          <a:xfrm flipV="1">
            <a:off x="4319640" y="1436400"/>
            <a:ext cx="0" cy="3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oup 24"/>
          <p:cNvGrpSpPr/>
          <p:nvPr/>
        </p:nvGrpSpPr>
        <p:grpSpPr>
          <a:xfrm>
            <a:off x="4282920" y="1231920"/>
            <a:ext cx="144720" cy="42840"/>
            <a:chOff x="4282920" y="1231920"/>
            <a:chExt cx="144720" cy="42840"/>
          </a:xfrm>
        </p:grpSpPr>
        <p:sp>
          <p:nvSpPr>
            <p:cNvPr id="59" name="Straight Connector 25"/>
            <p:cNvSpPr/>
            <p:nvPr/>
          </p:nvSpPr>
          <p:spPr>
            <a:xfrm>
              <a:off x="4282920" y="1231920"/>
              <a:ext cx="14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26"/>
            <p:cNvSpPr/>
            <p:nvPr/>
          </p:nvSpPr>
          <p:spPr>
            <a:xfrm flipV="1">
              <a:off x="4282920" y="123192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traight Connector 27"/>
            <p:cNvSpPr/>
            <p:nvPr/>
          </p:nvSpPr>
          <p:spPr>
            <a:xfrm flipV="1">
              <a:off x="4427640" y="1238040"/>
              <a:ext cx="0" cy="3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TextBox 28"/>
          <p:cNvSpPr/>
          <p:nvPr/>
        </p:nvSpPr>
        <p:spPr>
          <a:xfrm>
            <a:off x="3615480" y="20397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9"/>
          <p:cNvSpPr/>
          <p:nvPr/>
        </p:nvSpPr>
        <p:spPr>
          <a:xfrm>
            <a:off x="3673080" y="1535040"/>
            <a:ext cx="39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4052520" y="1255680"/>
            <a:ext cx="39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1"/>
          <p:cNvSpPr/>
          <p:nvPr/>
        </p:nvSpPr>
        <p:spPr>
          <a:xfrm>
            <a:off x="4161240" y="1063800"/>
            <a:ext cx="39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252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682560" y="6881760"/>
            <a:ext cx="56181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HBx in LO2 immortalized human hepatocyte cell line. (A) Effect of full-length HBx and Ct-HBx on cell proliferation. Growth of LO2 hepatocytes expressing full-length HBx, HBxΔ35 or empty vector control was determined by cell counting assay. Results are derived from 3 replicates of 2 independent experiments (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D). (B) Expression of miR-26a and miR-29c in LO2 hepatocytes expressing HBxΔ35 or empty vector control.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NA expression was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sured 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quantitative PCR using miScript Reverse Transcription and miScript SYBR Green PCR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(Qiagen).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5; **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1; ***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05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2:43:30Z</dcterms:created>
  <dc:creator>Alfred Cheng</dc:creator>
  <dc:description/>
  <dc:language>en-US</dc:language>
  <cp:lastModifiedBy>Alfred Cheng</cp:lastModifiedBy>
  <dcterms:modified xsi:type="dcterms:W3CDTF">2011-07-16T09:09:39Z</dcterms:modified>
  <cp:revision>18</cp:revision>
  <dc:subject/>
  <dc:title>Slide 1</dc:title>
</cp:coreProperties>
</file>